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7" r:id="rId2"/>
  </p:sldIdLst>
  <p:sldSz cx="9144000" cy="6858000" type="screen4x3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25" d="100"/>
          <a:sy n="125" d="100"/>
        </p:scale>
        <p:origin x="486" y="211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Master-Untertitelformat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91261-FE11-034D-9E12-433678FFB880}" type="datetimeFigureOut">
              <a:rPr lang="de-DE" smtClean="0"/>
              <a:pPr/>
              <a:t>08.02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E4E82-6474-0441-8FF3-DE77525007D8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24124225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91261-FE11-034D-9E12-433678FFB880}" type="datetimeFigureOut">
              <a:rPr lang="de-DE" smtClean="0"/>
              <a:pPr/>
              <a:t>08.02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E4E82-6474-0441-8FF3-DE77525007D8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25950985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91261-FE11-034D-9E12-433678FFB880}" type="datetimeFigureOut">
              <a:rPr lang="de-DE" smtClean="0"/>
              <a:pPr/>
              <a:t>08.02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E4E82-6474-0441-8FF3-DE77525007D8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22897906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91261-FE11-034D-9E12-433678FFB880}" type="datetimeFigureOut">
              <a:rPr lang="de-DE" smtClean="0"/>
              <a:pPr/>
              <a:t>08.02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E4E82-6474-0441-8FF3-DE77525007D8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23906534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91261-FE11-034D-9E12-433678FFB880}" type="datetimeFigureOut">
              <a:rPr lang="de-DE" smtClean="0"/>
              <a:pPr/>
              <a:t>08.02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E4E82-6474-0441-8FF3-DE77525007D8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25039152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91261-FE11-034D-9E12-433678FFB880}" type="datetimeFigureOut">
              <a:rPr lang="de-DE" smtClean="0"/>
              <a:pPr/>
              <a:t>08.02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E4E82-6474-0441-8FF3-DE77525007D8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42342057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91261-FE11-034D-9E12-433678FFB880}" type="datetimeFigureOut">
              <a:rPr lang="de-DE" smtClean="0"/>
              <a:pPr/>
              <a:t>08.02.20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E4E82-6474-0441-8FF3-DE77525007D8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19786794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91261-FE11-034D-9E12-433678FFB880}" type="datetimeFigureOut">
              <a:rPr lang="de-DE" smtClean="0"/>
              <a:pPr/>
              <a:t>08.02.20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E4E82-6474-0441-8FF3-DE77525007D8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21234163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91261-FE11-034D-9E12-433678FFB880}" type="datetimeFigureOut">
              <a:rPr lang="de-DE" smtClean="0"/>
              <a:pPr/>
              <a:t>08.02.20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E4E82-6474-0441-8FF3-DE77525007D8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11053020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91261-FE11-034D-9E12-433678FFB880}" type="datetimeFigureOut">
              <a:rPr lang="de-DE" smtClean="0"/>
              <a:pPr/>
              <a:t>08.02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E4E82-6474-0441-8FF3-DE77525007D8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6806008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91261-FE11-034D-9E12-433678FFB880}" type="datetimeFigureOut">
              <a:rPr lang="de-DE" smtClean="0"/>
              <a:pPr/>
              <a:t>08.02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E4E82-6474-0441-8FF3-DE77525007D8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1301688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491261-FE11-034D-9E12-433678FFB880}" type="datetimeFigureOut">
              <a:rPr lang="de-DE" smtClean="0"/>
              <a:pPr/>
              <a:t>08.02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FE4E82-6474-0441-8FF3-DE77525007D8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23406409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Inhaltsplatzhalt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="" xmlns:p14="http://schemas.microsoft.com/office/powerpoint/2010/main" val="2101508521"/>
              </p:ext>
            </p:extLst>
          </p:nvPr>
        </p:nvGraphicFramePr>
        <p:xfrm>
          <a:off x="457195" y="804794"/>
          <a:ext cx="8025505" cy="40212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74073"/>
                <a:gridCol w="223242"/>
                <a:gridCol w="250722"/>
                <a:gridCol w="312565"/>
                <a:gridCol w="225751"/>
                <a:gridCol w="279911"/>
                <a:gridCol w="374073"/>
                <a:gridCol w="374073"/>
                <a:gridCol w="374073"/>
                <a:gridCol w="374073"/>
                <a:gridCol w="374073"/>
                <a:gridCol w="374073"/>
                <a:gridCol w="374073"/>
                <a:gridCol w="374073"/>
                <a:gridCol w="374073"/>
                <a:gridCol w="374073"/>
                <a:gridCol w="374073"/>
                <a:gridCol w="374073"/>
                <a:gridCol w="374073"/>
                <a:gridCol w="374073"/>
                <a:gridCol w="374073"/>
                <a:gridCol w="374073"/>
                <a:gridCol w="374073"/>
              </a:tblGrid>
              <a:tr h="28055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 dirty="0">
                          <a:effectLst/>
                        </a:rPr>
                        <a:t>Rat 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 dirty="0" err="1">
                          <a:effectLst/>
                        </a:rPr>
                        <a:t>Weight</a:t>
                      </a:r>
                      <a:r>
                        <a:rPr lang="de-DE" sz="500" u="none" strike="noStrike" dirty="0">
                          <a:effectLst/>
                        </a:rPr>
                        <a:t> </a:t>
                      </a:r>
                      <a:r>
                        <a:rPr lang="de-DE" sz="500" u="none" strike="noStrike" dirty="0" smtClean="0">
                          <a:effectLst/>
                        </a:rPr>
                        <a:t> (g)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ge</a:t>
                      </a:r>
                      <a:r>
                        <a:rPr lang="de-DE" sz="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</a:t>
                      </a:r>
                      <a:r>
                        <a:rPr lang="de-DE" sz="500" b="0" i="0" u="none" strike="noStrike" baseline="0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eeks</a:t>
                      </a:r>
                      <a:r>
                        <a:rPr lang="de-DE" sz="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 dirty="0">
                          <a:effectLst/>
                        </a:rPr>
                        <a:t>heavy/light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 dirty="0">
                          <a:effectLst/>
                        </a:rPr>
                        <a:t>Side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enght </a:t>
                      </a:r>
                      <a:br>
                        <a:rPr lang="de-DE" sz="500" u="none" strike="noStrike">
                          <a:effectLst/>
                        </a:rPr>
                      </a:br>
                      <a:r>
                        <a:rPr lang="de-DE" sz="500" u="none" strike="noStrike">
                          <a:effectLst/>
                        </a:rPr>
                        <a:t>Femur</a:t>
                      </a:r>
                      <a:br>
                        <a:rPr lang="de-DE" sz="500" u="none" strike="noStrike">
                          <a:effectLst/>
                        </a:rPr>
                      </a:br>
                      <a:r>
                        <a:rPr lang="de-DE" sz="500" u="none" strike="noStrike">
                          <a:effectLst/>
                        </a:rPr>
                        <a:t>(mm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Failure load</a:t>
                      </a:r>
                      <a:br>
                        <a:rPr lang="de-DE" sz="500" u="none" strike="noStrike">
                          <a:effectLst/>
                        </a:rPr>
                      </a:br>
                      <a:r>
                        <a:rPr lang="de-DE" sz="500" u="none" strike="noStrike">
                          <a:effectLst/>
                        </a:rPr>
                        <a:t>Femur</a:t>
                      </a:r>
                      <a:br>
                        <a:rPr lang="de-DE" sz="500" u="none" strike="noStrike">
                          <a:effectLst/>
                        </a:rPr>
                      </a:br>
                      <a:r>
                        <a:rPr lang="de-DE" sz="500" u="none" strike="noStrike">
                          <a:effectLst/>
                        </a:rPr>
                        <a:t>(N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 dirty="0" err="1">
                          <a:effectLst/>
                        </a:rPr>
                        <a:t>Stiffness</a:t>
                      </a:r>
                      <a:r>
                        <a:rPr lang="de-DE" sz="500" u="none" strike="noStrike" dirty="0">
                          <a:effectLst/>
                        </a:rPr>
                        <a:t/>
                      </a:r>
                      <a:br>
                        <a:rPr lang="de-DE" sz="500" u="none" strike="noStrike" dirty="0">
                          <a:effectLst/>
                        </a:rPr>
                      </a:br>
                      <a:r>
                        <a:rPr lang="de-DE" sz="500" u="none" strike="noStrike" dirty="0">
                          <a:effectLst/>
                        </a:rPr>
                        <a:t>Femur</a:t>
                      </a:r>
                      <a:br>
                        <a:rPr lang="de-DE" sz="500" u="none" strike="noStrike" dirty="0">
                          <a:effectLst/>
                        </a:rPr>
                      </a:br>
                      <a:r>
                        <a:rPr lang="de-DE" sz="500" u="none" strike="noStrike" dirty="0">
                          <a:effectLst/>
                        </a:rPr>
                        <a:t>(</a:t>
                      </a:r>
                      <a:r>
                        <a:rPr lang="de-DE" sz="500" u="none" strike="noStrike" dirty="0" smtClean="0">
                          <a:effectLst/>
                        </a:rPr>
                        <a:t>N/mm</a:t>
                      </a:r>
                      <a:r>
                        <a:rPr lang="de-DE" sz="500" u="none" strike="noStrike" dirty="0">
                          <a:effectLst/>
                        </a:rPr>
                        <a:t>)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BMC DXA</a:t>
                      </a:r>
                      <a:br>
                        <a:rPr lang="de-DE" sz="500" u="none" strike="noStrike">
                          <a:effectLst/>
                        </a:rPr>
                      </a:br>
                      <a:r>
                        <a:rPr lang="de-DE" sz="500" u="none" strike="noStrike">
                          <a:effectLst/>
                        </a:rPr>
                        <a:t>Femur</a:t>
                      </a:r>
                      <a:br>
                        <a:rPr lang="de-DE" sz="500" u="none" strike="noStrike">
                          <a:effectLst/>
                        </a:rPr>
                      </a:br>
                      <a:r>
                        <a:rPr lang="de-DE" sz="500" u="none" strike="noStrike">
                          <a:effectLst/>
                        </a:rPr>
                        <a:t>(g/cm³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TOT_CNT Shaft</a:t>
                      </a:r>
                      <a:br>
                        <a:rPr lang="de-DE" sz="500" u="none" strike="noStrike">
                          <a:effectLst/>
                        </a:rPr>
                      </a:br>
                      <a:r>
                        <a:rPr lang="de-DE" sz="500" u="none" strike="noStrike">
                          <a:effectLst/>
                        </a:rPr>
                        <a:t>Femur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 dirty="0">
                          <a:effectLst/>
                        </a:rPr>
                        <a:t>CRT_CNT </a:t>
                      </a:r>
                      <a:r>
                        <a:rPr lang="de-DE" sz="500" u="none" strike="noStrike" dirty="0" err="1">
                          <a:effectLst/>
                        </a:rPr>
                        <a:t>Shaft</a:t>
                      </a:r>
                      <a:r>
                        <a:rPr lang="de-DE" sz="500" u="none" strike="noStrike" dirty="0">
                          <a:effectLst/>
                        </a:rPr>
                        <a:t/>
                      </a:r>
                      <a:br>
                        <a:rPr lang="de-DE" sz="500" u="none" strike="noStrike" dirty="0">
                          <a:effectLst/>
                        </a:rPr>
                      </a:br>
                      <a:r>
                        <a:rPr lang="de-DE" sz="500" u="none" strike="noStrike" dirty="0">
                          <a:effectLst/>
                        </a:rPr>
                        <a:t>Femur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enght </a:t>
                      </a:r>
                      <a:br>
                        <a:rPr lang="de-DE" sz="500" u="none" strike="noStrike">
                          <a:effectLst/>
                        </a:rPr>
                      </a:br>
                      <a:r>
                        <a:rPr lang="de-DE" sz="500" u="none" strike="noStrike">
                          <a:effectLst/>
                        </a:rPr>
                        <a:t>Tibia</a:t>
                      </a:r>
                      <a:br>
                        <a:rPr lang="de-DE" sz="500" u="none" strike="noStrike">
                          <a:effectLst/>
                        </a:rPr>
                      </a:br>
                      <a:r>
                        <a:rPr lang="de-DE" sz="500" u="none" strike="noStrike">
                          <a:effectLst/>
                        </a:rPr>
                        <a:t>(mm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Failure load</a:t>
                      </a:r>
                      <a:br>
                        <a:rPr lang="de-DE" sz="500" u="none" strike="noStrike">
                          <a:effectLst/>
                        </a:rPr>
                      </a:br>
                      <a:r>
                        <a:rPr lang="de-DE" sz="500" u="none" strike="noStrike">
                          <a:effectLst/>
                        </a:rPr>
                        <a:t>Tibia</a:t>
                      </a:r>
                      <a:br>
                        <a:rPr lang="de-DE" sz="500" u="none" strike="noStrike">
                          <a:effectLst/>
                        </a:rPr>
                      </a:br>
                      <a:r>
                        <a:rPr lang="de-DE" sz="500" u="none" strike="noStrike">
                          <a:effectLst/>
                        </a:rPr>
                        <a:t>(N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 dirty="0" err="1">
                          <a:effectLst/>
                        </a:rPr>
                        <a:t>Stiffness</a:t>
                      </a:r>
                      <a:r>
                        <a:rPr lang="de-DE" sz="500" u="none" strike="noStrike" dirty="0">
                          <a:effectLst/>
                        </a:rPr>
                        <a:t/>
                      </a:r>
                      <a:br>
                        <a:rPr lang="de-DE" sz="500" u="none" strike="noStrike" dirty="0">
                          <a:effectLst/>
                        </a:rPr>
                      </a:br>
                      <a:r>
                        <a:rPr lang="de-DE" sz="500" u="none" strike="noStrike" dirty="0">
                          <a:effectLst/>
                        </a:rPr>
                        <a:t>Tibia</a:t>
                      </a:r>
                      <a:br>
                        <a:rPr lang="de-DE" sz="500" u="none" strike="noStrike" dirty="0">
                          <a:effectLst/>
                        </a:rPr>
                      </a:br>
                      <a:r>
                        <a:rPr lang="de-DE" sz="500" u="none" strike="noStrike" dirty="0">
                          <a:effectLst/>
                        </a:rPr>
                        <a:t>(</a:t>
                      </a:r>
                      <a:r>
                        <a:rPr lang="de-DE" sz="500" u="none" strike="noStrike" dirty="0" smtClean="0">
                          <a:effectLst/>
                        </a:rPr>
                        <a:t>N/mm</a:t>
                      </a:r>
                      <a:r>
                        <a:rPr lang="de-DE" sz="500" u="none" strike="noStrike" dirty="0">
                          <a:effectLst/>
                        </a:rPr>
                        <a:t>)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BMC DXA</a:t>
                      </a:r>
                      <a:br>
                        <a:rPr lang="de-DE" sz="500" u="none" strike="noStrike">
                          <a:effectLst/>
                        </a:rPr>
                      </a:br>
                      <a:r>
                        <a:rPr lang="de-DE" sz="500" u="none" strike="noStrike">
                          <a:effectLst/>
                        </a:rPr>
                        <a:t>Tibia</a:t>
                      </a:r>
                      <a:br>
                        <a:rPr lang="de-DE" sz="500" u="none" strike="noStrike">
                          <a:effectLst/>
                        </a:rPr>
                      </a:br>
                      <a:r>
                        <a:rPr lang="de-DE" sz="500" u="none" strike="noStrike">
                          <a:effectLst/>
                        </a:rPr>
                        <a:t>(g/cm³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TOT_CNT Shaft</a:t>
                      </a:r>
                      <a:br>
                        <a:rPr lang="de-DE" sz="500" u="none" strike="noStrike">
                          <a:effectLst/>
                        </a:rPr>
                      </a:br>
                      <a:r>
                        <a:rPr lang="de-DE" sz="500" u="none" strike="noStrike">
                          <a:effectLst/>
                        </a:rPr>
                        <a:t>Tibia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 dirty="0">
                          <a:effectLst/>
                        </a:rPr>
                        <a:t>CRT_CNT </a:t>
                      </a:r>
                      <a:r>
                        <a:rPr lang="de-DE" sz="500" u="none" strike="noStrike" dirty="0" err="1">
                          <a:effectLst/>
                        </a:rPr>
                        <a:t>Shaft</a:t>
                      </a:r>
                      <a:r>
                        <a:rPr lang="de-DE" sz="500" u="none" strike="noStrike" dirty="0">
                          <a:effectLst/>
                        </a:rPr>
                        <a:t/>
                      </a:r>
                      <a:br>
                        <a:rPr lang="de-DE" sz="500" u="none" strike="noStrike" dirty="0">
                          <a:effectLst/>
                        </a:rPr>
                      </a:br>
                      <a:r>
                        <a:rPr lang="de-DE" sz="500" u="none" strike="noStrike" dirty="0">
                          <a:effectLst/>
                        </a:rPr>
                        <a:t>Tibia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enght</a:t>
                      </a:r>
                      <a:br>
                        <a:rPr lang="de-DE" sz="500" u="none" strike="noStrike">
                          <a:effectLst/>
                        </a:rPr>
                      </a:br>
                      <a:r>
                        <a:rPr lang="de-DE" sz="500" u="none" strike="noStrike">
                          <a:effectLst/>
                        </a:rPr>
                        <a:t>Humerus</a:t>
                      </a:r>
                      <a:br>
                        <a:rPr lang="de-DE" sz="500" u="none" strike="noStrike">
                          <a:effectLst/>
                        </a:rPr>
                      </a:br>
                      <a:r>
                        <a:rPr lang="de-DE" sz="500" u="none" strike="noStrike">
                          <a:effectLst/>
                        </a:rPr>
                        <a:t>(mm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Failure load</a:t>
                      </a:r>
                      <a:br>
                        <a:rPr lang="de-DE" sz="500" u="none" strike="noStrike">
                          <a:effectLst/>
                        </a:rPr>
                      </a:br>
                      <a:r>
                        <a:rPr lang="de-DE" sz="500" u="none" strike="noStrike">
                          <a:effectLst/>
                        </a:rPr>
                        <a:t>Humerus</a:t>
                      </a:r>
                      <a:br>
                        <a:rPr lang="de-DE" sz="500" u="none" strike="noStrike">
                          <a:effectLst/>
                        </a:rPr>
                      </a:br>
                      <a:r>
                        <a:rPr lang="de-DE" sz="500" u="none" strike="noStrike">
                          <a:effectLst/>
                        </a:rPr>
                        <a:t>(N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 dirty="0" err="1">
                          <a:effectLst/>
                        </a:rPr>
                        <a:t>Stiffness</a:t>
                      </a:r>
                      <a:r>
                        <a:rPr lang="de-DE" sz="500" u="none" strike="noStrike" dirty="0">
                          <a:effectLst/>
                        </a:rPr>
                        <a:t> </a:t>
                      </a:r>
                      <a:br>
                        <a:rPr lang="de-DE" sz="500" u="none" strike="noStrike" dirty="0">
                          <a:effectLst/>
                        </a:rPr>
                      </a:br>
                      <a:r>
                        <a:rPr lang="de-DE" sz="500" u="none" strike="noStrike" dirty="0" err="1">
                          <a:effectLst/>
                        </a:rPr>
                        <a:t>Humerus</a:t>
                      </a:r>
                      <a:r>
                        <a:rPr lang="de-DE" sz="500" u="none" strike="noStrike" dirty="0">
                          <a:effectLst/>
                        </a:rPr>
                        <a:t/>
                      </a:r>
                      <a:br>
                        <a:rPr lang="de-DE" sz="500" u="none" strike="noStrike" dirty="0">
                          <a:effectLst/>
                        </a:rPr>
                      </a:br>
                      <a:r>
                        <a:rPr lang="de-DE" sz="500" u="none" strike="noStrike" dirty="0">
                          <a:effectLst/>
                        </a:rPr>
                        <a:t>(</a:t>
                      </a:r>
                      <a:r>
                        <a:rPr lang="de-DE" sz="500" u="none" strike="noStrike" dirty="0" smtClean="0">
                          <a:effectLst/>
                        </a:rPr>
                        <a:t>N/mm</a:t>
                      </a:r>
                      <a:r>
                        <a:rPr lang="de-DE" sz="500" u="none" strike="noStrike" dirty="0">
                          <a:effectLst/>
                        </a:rPr>
                        <a:t>)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BMC DXA</a:t>
                      </a:r>
                      <a:br>
                        <a:rPr lang="de-DE" sz="500" u="none" strike="noStrike">
                          <a:effectLst/>
                        </a:rPr>
                      </a:br>
                      <a:r>
                        <a:rPr lang="de-DE" sz="500" u="none" strike="noStrike">
                          <a:effectLst/>
                        </a:rPr>
                        <a:t>Humerus</a:t>
                      </a:r>
                      <a:br>
                        <a:rPr lang="de-DE" sz="500" u="none" strike="noStrike">
                          <a:effectLst/>
                        </a:rPr>
                      </a:br>
                      <a:r>
                        <a:rPr lang="de-DE" sz="500" u="none" strike="noStrike">
                          <a:effectLst/>
                        </a:rPr>
                        <a:t>(g/cm³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TOT_CNT Shaft</a:t>
                      </a:r>
                      <a:br>
                        <a:rPr lang="de-DE" sz="500" u="none" strike="noStrike">
                          <a:effectLst/>
                        </a:rPr>
                      </a:br>
                      <a:r>
                        <a:rPr lang="de-DE" sz="500" u="none" strike="noStrike">
                          <a:effectLst/>
                        </a:rPr>
                        <a:t>Humerus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CRT_CNT Shaft</a:t>
                      </a:r>
                      <a:br>
                        <a:rPr lang="de-DE" sz="500" u="none" strike="noStrike">
                          <a:effectLst/>
                        </a:rPr>
                      </a:br>
                      <a:r>
                        <a:rPr lang="de-DE" sz="500" u="none" strike="noStrike">
                          <a:effectLst/>
                        </a:rPr>
                        <a:t>Humerus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4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r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1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2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27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,4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,8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247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8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2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5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150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2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,7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4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2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6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25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,5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,9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3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248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7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3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7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152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1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,6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5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r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3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9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33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,7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,9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248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8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3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2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166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1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,7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5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2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3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36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,6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,9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2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243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8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2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0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159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0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,6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5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r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4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8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17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,6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,9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1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238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5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0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9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15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0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,6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5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3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8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22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,8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,0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2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242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5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0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8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155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2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,7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3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r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3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6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2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,6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,9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1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22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7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9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150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,9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,5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3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3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1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1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1,0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,2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231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6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9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152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,9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,5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4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r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6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9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414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,5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,8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7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00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,1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,4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8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189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,4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9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4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6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7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415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1,2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,3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7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291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,2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,7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9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189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,2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7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3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r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4,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4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1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38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,8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,1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241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8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2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1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167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2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,8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3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4,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3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4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22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,6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,0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23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5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,9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8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171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2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,7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4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r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2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4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27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,9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,2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249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,1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6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0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157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,8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4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2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6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28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,9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,3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3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248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,0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5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1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158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3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,9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4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r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7,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4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3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449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,6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,8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4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2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,1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,6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4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215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,0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5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4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7,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3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0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473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,7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,0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5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25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,9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,4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5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217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,3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8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5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h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r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3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2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731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4,9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3,6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4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7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549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1,0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,2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9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2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26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,5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,8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5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h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3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8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758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5,3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3,9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6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7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582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1,1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,3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8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2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30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,7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,9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5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h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r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3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726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4,6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3,5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5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7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58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1,9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,9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7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0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5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1,1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,2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5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h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3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5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735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4,5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3,4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5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7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577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1,3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,3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7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2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54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1,1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,2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6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h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r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4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79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5,6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4,3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2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6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576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1,3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,4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0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4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62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1,7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,7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6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h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3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3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78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5,3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3,7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9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 dirty="0">
                          <a:effectLst/>
                        </a:rPr>
                        <a:t>0,5839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1,4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,6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8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6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72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1,3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,5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9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h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r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0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5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717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4,1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3,0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4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7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523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,6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,9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4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0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24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,6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,9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9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h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1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1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739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4,0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2,9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7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5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521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,6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,8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6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1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,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,2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4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h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r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1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827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6,2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4,9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7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7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597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2,1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1,2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7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0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56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,7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,1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4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h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1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6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836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6,1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4,8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7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8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596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1,7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,9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8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0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62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,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,4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8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h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r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4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8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693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5,6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4,6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5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8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617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2,4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1,4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7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8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,7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,1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8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h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2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2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837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5,7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4,4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5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9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632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2,0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1,2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7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2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58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,0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,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9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h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r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1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3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77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4,9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3,7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5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0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541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1,0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,1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4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2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35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,8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,2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9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h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9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5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78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5,0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3,9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5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6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552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,5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,7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5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1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33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,6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,8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5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h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r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5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2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856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6,9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5,5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5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4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602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1,7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,9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4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3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68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1,0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,2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5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h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3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7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84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6,9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5,5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4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4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1,5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,6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7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1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6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1,3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,4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8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r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7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9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585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2,0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1,1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5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96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,1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,6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3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257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,9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,5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8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7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5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589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3,8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2,6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2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7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408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,3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,8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4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259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,9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,4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4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h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r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7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2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69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3,6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2,7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1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4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488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,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,3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4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14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,5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,0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4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h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9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5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723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4,4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3,4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3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7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492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,0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,3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2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7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1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,8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,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7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r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3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9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462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,8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,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3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41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,2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,7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9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211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9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6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7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7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48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0,3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,4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2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24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,7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6,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6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215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8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5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5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r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2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5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53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,1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,3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251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7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2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1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16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4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  <a:tr h="9351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 dirty="0">
                          <a:effectLst/>
                        </a:rPr>
                        <a:t>354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l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12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5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351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8,0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,2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4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7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243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8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2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9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2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0,16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>
                          <a:effectLst/>
                        </a:rPr>
                        <a:t>5,4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u="none" strike="noStrike" dirty="0">
                          <a:effectLst/>
                        </a:rPr>
                        <a:t>5,08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76" marR="4676" marT="4676" marB="0" anchor="ctr"/>
                </a:tc>
              </a:tr>
            </a:tbl>
          </a:graphicData>
        </a:graphic>
      </p:graphicFrame>
      <p:sp>
        <p:nvSpPr>
          <p:cNvPr id="4" name="Textfeld 3"/>
          <p:cNvSpPr txBox="1"/>
          <p:nvPr/>
        </p:nvSpPr>
        <p:spPr>
          <a:xfrm>
            <a:off x="1398337" y="5010215"/>
            <a:ext cx="77456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Data, Table 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: </a:t>
            </a:r>
            <a:r>
              <a:rPr lang="de-DE" alt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ata-summary: Radiological and biomechanical results of each bone.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17327312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77</Words>
  <Application>Microsoft Office PowerPoint</Application>
  <PresentationFormat>On-screen Show (4:3)</PresentationFormat>
  <Paragraphs>94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-Design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Peter Prodinger</dc:creator>
  <cp:lastModifiedBy>0013357</cp:lastModifiedBy>
  <cp:revision>54</cp:revision>
  <dcterms:created xsi:type="dcterms:W3CDTF">2017-08-19T13:21:20Z</dcterms:created>
  <dcterms:modified xsi:type="dcterms:W3CDTF">2018-02-08T14:59:04Z</dcterms:modified>
</cp:coreProperties>
</file>